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E0EDE8-7D71-4528-80F3-D0755AE9B0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9C92903-E7EC-4978-A474-96378F0237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9D3716-FE68-436D-969F-A12F9BB41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39CBB-FAC4-4BB3-88EE-2EFB38953626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01BDD6-D4C3-45F2-B602-CD855A454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45302E-F950-4CBA-8C57-93A62CA4D6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AC0ED-CDE2-4422-8A38-11D36101824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730472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6AA377-256C-47A0-9ECB-834B0D42F3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DAE89E-3A10-463C-85F5-2EEFA44FAA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872303-59F8-4DE2-8043-9115181A4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39CBB-FAC4-4BB3-88EE-2EFB38953626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4C5A18-F98B-4987-BA71-82920CD57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69F3D1-E792-47D6-B939-8CB1FF79F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AC0ED-CDE2-4422-8A38-11D36101824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634447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7CAF74E-8365-4F0D-86C2-690F96B8C8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9FFC73-ABFE-4A48-9C6A-854D721E5E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A964E5-BA7E-4B62-B5A7-897614114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39CBB-FAC4-4BB3-88EE-2EFB38953626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7F17CA-51F1-4B87-AC17-F1A78555F1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6763D-A418-4A5D-96CA-AD8906F9E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AC0ED-CDE2-4422-8A38-11D36101824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4421576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5C2571-C3CC-400C-8156-2AA8EF847A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22EA0A-596E-4182-AB41-016F2D6FEA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2FF670-4706-4E32-B583-02049E5ED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39CBB-FAC4-4BB3-88EE-2EFB38953626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24A0B1-4D1F-43DE-B73B-0B66539D9C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5F8C9C-A107-4CB1-8DD6-467654F16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AC0ED-CDE2-4422-8A38-11D36101824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700821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0096EE-1C8F-41CC-BA87-792601D4D2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9C6636-6C3A-407C-8302-72F4E114D9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B1E74-2F49-4EB0-8711-F1E194C82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39CBB-FAC4-4BB3-88EE-2EFB38953626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9CBC60-A2B5-4F57-A355-F3AEC02AD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3872F6-FCA6-45C0-B7E4-4C846947F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AC0ED-CDE2-4422-8A38-11D36101824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820601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EB6868-95DE-4BA0-93C5-6F02844338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F45681-ED43-4ADA-AEC8-42E6836480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E2E32A-84BC-48A2-87EF-FFD7FD5634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4E3325-4AB0-4BE6-8847-1DB5208BCF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39CBB-FAC4-4BB3-88EE-2EFB38953626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524881-4F4C-4BB3-A746-DD7898725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5D431E-9C3F-4243-AC83-77103D4FD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AC0ED-CDE2-4422-8A38-11D36101824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804206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E320FD-A765-4E28-ABFC-9A1F7FB569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FBF80A-F024-4B7F-B0C4-C1DEECC255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CFF4E4-4816-41DD-BEBB-155CFD8259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1AA999-D216-4250-8218-1EEB58ACE6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E5E6262-B9B8-4C53-9A3D-3E5A083BAC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F6FBDFF-550F-4F87-B340-5F2B641AA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39CBB-FAC4-4BB3-88EE-2EFB38953626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770AB82-1010-4172-AD67-1DB6E6DE8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DC2501-0010-40A8-B5A7-2B5BD52CA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AC0ED-CDE2-4422-8A38-11D36101824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8995531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52E714-D49B-4E25-877A-6DB0B3C1B8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1F38EF-9515-492C-9C32-1D25B0257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39CBB-FAC4-4BB3-88EE-2EFB38953626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0F8E2F7-1A2E-4F43-BF69-69F764714D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BE48D0-E047-4AEC-8B54-C51CAE6B7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AC0ED-CDE2-4422-8A38-11D36101824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633459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482F71-2D64-4BBE-9386-2B4BD79C9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39CBB-FAC4-4BB3-88EE-2EFB38953626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69376AF-5A3D-4B71-9D0C-801E47A36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26EC3F9-F944-4345-8659-87DE591FB5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AC0ED-CDE2-4422-8A38-11D36101824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996701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653DC9-4D59-492C-A307-D09CF17769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B7D5C4-EC22-423B-9FE3-BC0885A6A9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DB539E-B076-428F-BD65-C1269CF00D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1E6470-9D2F-4C92-B12D-55E90A706B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39CBB-FAC4-4BB3-88EE-2EFB38953626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FA0C0A-5315-4B4D-8575-AE640AD3D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DDFCCB-C123-4F90-AB9F-020DE3556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AC0ED-CDE2-4422-8A38-11D36101824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24846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D3C97-9E26-4907-AE28-ACE4142A9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04A00A2-5338-4288-826F-684161AC9A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DC28BC-B0F4-44F0-A30D-858B3AC239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BE9E0-C962-444F-B61D-0AAEEA5790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39CBB-FAC4-4BB3-88EE-2EFB38953626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3BBFA0-FA13-4F2F-95E4-8B0225B640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8D0C5D-5CA3-4510-A2FB-09957FB52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AC0ED-CDE2-4422-8A38-11D36101824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203700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5EA982B-0C3F-428F-9972-BAC8AFB1CB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29DC8A-F111-454C-8D57-366FFA736A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8DC793-6AAE-455D-8FDD-73726A6321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39CBB-FAC4-4BB3-88EE-2EFB38953626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7F1E20-9068-40B6-AC25-FA590297A3A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B52B42-0A00-4B89-9441-7003F6F9BB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7AC0ED-CDE2-4422-8A38-11D361018246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4230798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96B92E4-9367-43C9-A7D3-FE0FC2132B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6363" y="964368"/>
            <a:ext cx="7326684" cy="497503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94F6496-42CB-5E4D-5B68-F0CA55EAFCF9}"/>
              </a:ext>
            </a:extLst>
          </p:cNvPr>
          <p:cNvSpPr txBox="1"/>
          <p:nvPr/>
        </p:nvSpPr>
        <p:spPr>
          <a:xfrm>
            <a:off x="4043494" y="1921079"/>
            <a:ext cx="53046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7a. Reference range of WBC, RBC, HGB, HCT, MCV, MCH, MCHC for healthy babies aged 4 months</a:t>
            </a:r>
          </a:p>
        </p:txBody>
      </p:sp>
    </p:spTree>
    <p:extLst>
      <p:ext uri="{BB962C8B-B14F-4D97-AF65-F5344CB8AC3E}">
        <p14:creationId xmlns:p14="http://schemas.microsoft.com/office/powerpoint/2010/main" val="41585155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7F25693-4140-4179-BC48-BF3AD87B63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9939" y="947956"/>
            <a:ext cx="8602726" cy="499144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B2D03F6-234A-20E3-557B-B06C893D93C6}"/>
              </a:ext>
            </a:extLst>
          </p:cNvPr>
          <p:cNvSpPr txBox="1"/>
          <p:nvPr/>
        </p:nvSpPr>
        <p:spPr>
          <a:xfrm>
            <a:off x="3389153" y="1937857"/>
            <a:ext cx="57632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7b. Reference range of PLT, RDW SD, RDW CV, PDW, MPV, PCT, neutrophil for healthy babies aged 4 months</a:t>
            </a:r>
          </a:p>
        </p:txBody>
      </p:sp>
    </p:spTree>
    <p:extLst>
      <p:ext uri="{BB962C8B-B14F-4D97-AF65-F5344CB8AC3E}">
        <p14:creationId xmlns:p14="http://schemas.microsoft.com/office/powerpoint/2010/main" val="4291526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96301DE-84C7-49FF-B6E2-82F823BDE6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3062" y="1062037"/>
            <a:ext cx="8905875" cy="473392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084245B-EC7A-C208-514A-5E95E106C0F0}"/>
              </a:ext>
            </a:extLst>
          </p:cNvPr>
          <p:cNvSpPr txBox="1"/>
          <p:nvPr/>
        </p:nvSpPr>
        <p:spPr>
          <a:xfrm>
            <a:off x="3162649" y="1988191"/>
            <a:ext cx="671119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 dirty="0"/>
              <a:t>Table 7c. Reference range of lymphocyte, monocyte, eosinophil, eosinophil </a:t>
            </a:r>
            <a:r>
              <a:rPr lang="en-ID" dirty="0" err="1"/>
              <a:t>absolut</a:t>
            </a:r>
            <a:r>
              <a:rPr lang="en-ID" dirty="0"/>
              <a:t>, basophil, basophil </a:t>
            </a:r>
            <a:r>
              <a:rPr lang="en-ID" dirty="0" err="1"/>
              <a:t>absolut</a:t>
            </a:r>
            <a:r>
              <a:rPr lang="en-ID" dirty="0"/>
              <a:t>, IPF, IG for healthy babies aged 4 months</a:t>
            </a:r>
          </a:p>
        </p:txBody>
      </p:sp>
    </p:spTree>
    <p:extLst>
      <p:ext uri="{BB962C8B-B14F-4D97-AF65-F5344CB8AC3E}">
        <p14:creationId xmlns:p14="http://schemas.microsoft.com/office/powerpoint/2010/main" val="1887347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16DF232-3869-47AE-B2C1-7B7E32F0FD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25277" y="872455"/>
            <a:ext cx="6890249" cy="538573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769BDD6-4A5F-9A13-A5A6-49C6497D2244}"/>
              </a:ext>
            </a:extLst>
          </p:cNvPr>
          <p:cNvSpPr txBox="1"/>
          <p:nvPr/>
        </p:nvSpPr>
        <p:spPr>
          <a:xfrm>
            <a:off x="4488110" y="1719743"/>
            <a:ext cx="550317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 dirty="0"/>
              <a:t>Table 7d. Reference range of reticulocyte </a:t>
            </a:r>
            <a:r>
              <a:rPr lang="en-ID" dirty="0" err="1"/>
              <a:t>hemoglobin</a:t>
            </a:r>
            <a:r>
              <a:rPr lang="en-ID" dirty="0"/>
              <a:t>, reticulocyte </a:t>
            </a:r>
            <a:r>
              <a:rPr lang="en-ID" dirty="0" err="1"/>
              <a:t>hemoglobin</a:t>
            </a:r>
            <a:r>
              <a:rPr lang="en-ID" dirty="0"/>
              <a:t> %, reticulocyte </a:t>
            </a:r>
            <a:r>
              <a:rPr lang="en-ID" dirty="0" err="1"/>
              <a:t>hemoglobin</a:t>
            </a:r>
            <a:r>
              <a:rPr lang="en-ID" dirty="0"/>
              <a:t> in million, IRF, RPI for healthy babies aged 4 months</a:t>
            </a:r>
          </a:p>
        </p:txBody>
      </p:sp>
    </p:spTree>
    <p:extLst>
      <p:ext uri="{BB962C8B-B14F-4D97-AF65-F5344CB8AC3E}">
        <p14:creationId xmlns:p14="http://schemas.microsoft.com/office/powerpoint/2010/main" val="1177132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07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lindungan ringoringo</dc:creator>
  <cp:lastModifiedBy>parlindungan ringoringo</cp:lastModifiedBy>
  <cp:revision>2</cp:revision>
  <dcterms:created xsi:type="dcterms:W3CDTF">2022-02-16T22:03:18Z</dcterms:created>
  <dcterms:modified xsi:type="dcterms:W3CDTF">2022-07-23T22:59:47Z</dcterms:modified>
</cp:coreProperties>
</file>